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54"/>
  </p:normalViewPr>
  <p:slideViewPr>
    <p:cSldViewPr snapToGrid="0">
      <p:cViewPr>
        <p:scale>
          <a:sx n="60" d="100"/>
          <a:sy n="60" d="100"/>
        </p:scale>
        <p:origin x="2352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57184-3554-AD4D-AE53-4B57AC2792D5}" type="datetimeFigureOut">
              <a:rPr lang="en-GR" smtClean="0"/>
              <a:t>28/6/23</a:t>
            </a:fld>
            <a:endParaRPr lang="en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68450-1406-664E-8229-8BC363742D80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1947069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57184-3554-AD4D-AE53-4B57AC2792D5}" type="datetimeFigureOut">
              <a:rPr lang="en-GR" smtClean="0"/>
              <a:t>28/6/23</a:t>
            </a:fld>
            <a:endParaRPr lang="en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68450-1406-664E-8229-8BC363742D80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4030356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57184-3554-AD4D-AE53-4B57AC2792D5}" type="datetimeFigureOut">
              <a:rPr lang="en-GR" smtClean="0"/>
              <a:t>28/6/23</a:t>
            </a:fld>
            <a:endParaRPr lang="en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68450-1406-664E-8229-8BC363742D80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3312775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57184-3554-AD4D-AE53-4B57AC2792D5}" type="datetimeFigureOut">
              <a:rPr lang="en-GR" smtClean="0"/>
              <a:t>28/6/23</a:t>
            </a:fld>
            <a:endParaRPr lang="en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68450-1406-664E-8229-8BC363742D80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437832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57184-3554-AD4D-AE53-4B57AC2792D5}" type="datetimeFigureOut">
              <a:rPr lang="en-GR" smtClean="0"/>
              <a:t>28/6/23</a:t>
            </a:fld>
            <a:endParaRPr lang="en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68450-1406-664E-8229-8BC363742D80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3459686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57184-3554-AD4D-AE53-4B57AC2792D5}" type="datetimeFigureOut">
              <a:rPr lang="en-GR" smtClean="0"/>
              <a:t>28/6/23</a:t>
            </a:fld>
            <a:endParaRPr lang="en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68450-1406-664E-8229-8BC363742D80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4119127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57184-3554-AD4D-AE53-4B57AC2792D5}" type="datetimeFigureOut">
              <a:rPr lang="en-GR" smtClean="0"/>
              <a:t>28/6/23</a:t>
            </a:fld>
            <a:endParaRPr lang="en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68450-1406-664E-8229-8BC363742D80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1324898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57184-3554-AD4D-AE53-4B57AC2792D5}" type="datetimeFigureOut">
              <a:rPr lang="en-GR" smtClean="0"/>
              <a:t>28/6/23</a:t>
            </a:fld>
            <a:endParaRPr lang="en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68450-1406-664E-8229-8BC363742D80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30108016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57184-3554-AD4D-AE53-4B57AC2792D5}" type="datetimeFigureOut">
              <a:rPr lang="en-GR" smtClean="0"/>
              <a:t>28/6/23</a:t>
            </a:fld>
            <a:endParaRPr lang="en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68450-1406-664E-8229-8BC363742D80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399754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57184-3554-AD4D-AE53-4B57AC2792D5}" type="datetimeFigureOut">
              <a:rPr lang="en-GR" smtClean="0"/>
              <a:t>28/6/23</a:t>
            </a:fld>
            <a:endParaRPr lang="en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68450-1406-664E-8229-8BC363742D80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39601847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57184-3554-AD4D-AE53-4B57AC2792D5}" type="datetimeFigureOut">
              <a:rPr lang="en-GR" smtClean="0"/>
              <a:t>28/6/23</a:t>
            </a:fld>
            <a:endParaRPr lang="en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68450-1406-664E-8229-8BC363742D80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6122897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57184-3554-AD4D-AE53-4B57AC2792D5}" type="datetimeFigureOut">
              <a:rPr lang="en-GR" smtClean="0"/>
              <a:t>28/6/23</a:t>
            </a:fld>
            <a:endParaRPr lang="en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468450-1406-664E-8229-8BC363742D80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1498775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"/><Relationship Id="rId3" Type="http://schemas.openxmlformats.org/officeDocument/2006/relationships/image" Target="../media/image10.tif"/><Relationship Id="rId7" Type="http://schemas.openxmlformats.org/officeDocument/2006/relationships/image" Target="../media/image14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3.tif"/><Relationship Id="rId5" Type="http://schemas.openxmlformats.org/officeDocument/2006/relationships/image" Target="../media/image12.tif"/><Relationship Id="rId4" Type="http://schemas.openxmlformats.org/officeDocument/2006/relationships/image" Target="../media/image11.tif"/><Relationship Id="rId9" Type="http://schemas.openxmlformats.org/officeDocument/2006/relationships/image" Target="../media/image1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picture containing invertebrate, darkness&#10;&#10;Description automatically generated">
            <a:extLst>
              <a:ext uri="{FF2B5EF4-FFF2-40B4-BE49-F238E27FC236}">
                <a16:creationId xmlns:a16="http://schemas.microsoft.com/office/drawing/2014/main" id="{443E0FF3-6147-1AFA-2029-6BCFD710FF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3063" y="4211894"/>
            <a:ext cx="2343151" cy="2343151"/>
          </a:xfrm>
          <a:prstGeom prst="rect">
            <a:avLst/>
          </a:prstGeom>
        </p:spPr>
      </p:pic>
      <p:pic>
        <p:nvPicPr>
          <p:cNvPr id="8" name="Picture 7" descr="A picture containing invertebrate, green&#10;&#10;Description automatically generated">
            <a:extLst>
              <a:ext uri="{FF2B5EF4-FFF2-40B4-BE49-F238E27FC236}">
                <a16:creationId xmlns:a16="http://schemas.microsoft.com/office/drawing/2014/main" id="{6BE11FAF-BD21-4FD5-4366-3E109CB8AB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43062" y="1529523"/>
            <a:ext cx="2343152" cy="2343152"/>
          </a:xfrm>
          <a:prstGeom prst="rect">
            <a:avLst/>
          </a:prstGeom>
        </p:spPr>
      </p:pic>
      <p:pic>
        <p:nvPicPr>
          <p:cNvPr id="10" name="Picture 9" descr="A picture containing green, invertebrate&#10;&#10;Description automatically generated">
            <a:extLst>
              <a:ext uri="{FF2B5EF4-FFF2-40B4-BE49-F238E27FC236}">
                <a16:creationId xmlns:a16="http://schemas.microsoft.com/office/drawing/2014/main" id="{35DAD3EB-18D4-E94E-C482-C9F5F6C6BB9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43062" y="6894264"/>
            <a:ext cx="2343152" cy="2343152"/>
          </a:xfrm>
          <a:prstGeom prst="rect">
            <a:avLst/>
          </a:prstGeom>
        </p:spPr>
      </p:pic>
      <p:pic>
        <p:nvPicPr>
          <p:cNvPr id="12" name="Picture 11" descr="A picture containing green&#10;&#10;Description automatically generated">
            <a:extLst>
              <a:ext uri="{FF2B5EF4-FFF2-40B4-BE49-F238E27FC236}">
                <a16:creationId xmlns:a16="http://schemas.microsoft.com/office/drawing/2014/main" id="{414CFE1B-9325-7AED-A10B-4BE93E60933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43062" y="9576633"/>
            <a:ext cx="2343152" cy="2343152"/>
          </a:xfrm>
          <a:prstGeom prst="rect">
            <a:avLst/>
          </a:prstGeom>
        </p:spPr>
      </p:pic>
      <p:pic>
        <p:nvPicPr>
          <p:cNvPr id="14" name="Picture 13" descr="A picture containing invertebrate, bioluminescence, majorelle blue, marine invertebrates&#10;&#10;Description automatically generated">
            <a:extLst>
              <a:ext uri="{FF2B5EF4-FFF2-40B4-BE49-F238E27FC236}">
                <a16:creationId xmlns:a16="http://schemas.microsoft.com/office/drawing/2014/main" id="{386B5398-EA6F-38CD-0B81-26195F7D4A5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22749" y="4211893"/>
            <a:ext cx="2343151" cy="2343151"/>
          </a:xfrm>
          <a:prstGeom prst="rect">
            <a:avLst/>
          </a:prstGeom>
        </p:spPr>
      </p:pic>
      <p:pic>
        <p:nvPicPr>
          <p:cNvPr id="16" name="Picture 15" descr="A picture containing darkness, screenshot, majorelle blue, electric blue&#10;&#10;Description automatically generated">
            <a:extLst>
              <a:ext uri="{FF2B5EF4-FFF2-40B4-BE49-F238E27FC236}">
                <a16:creationId xmlns:a16="http://schemas.microsoft.com/office/drawing/2014/main" id="{29BD0243-64E9-1C5C-BA6E-AA2919FD72B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22749" y="1529523"/>
            <a:ext cx="2343151" cy="2343151"/>
          </a:xfrm>
          <a:prstGeom prst="rect">
            <a:avLst/>
          </a:prstGeom>
        </p:spPr>
      </p:pic>
      <p:pic>
        <p:nvPicPr>
          <p:cNvPr id="18" name="Picture 17" descr="Blue dots on a black background&#10;&#10;Description automatically generated with low confidence">
            <a:extLst>
              <a:ext uri="{FF2B5EF4-FFF2-40B4-BE49-F238E27FC236}">
                <a16:creationId xmlns:a16="http://schemas.microsoft.com/office/drawing/2014/main" id="{494E46EE-E926-9023-85D8-A9063AFE760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22749" y="6894265"/>
            <a:ext cx="2343151" cy="2343151"/>
          </a:xfrm>
          <a:prstGeom prst="rect">
            <a:avLst/>
          </a:prstGeom>
        </p:spPr>
      </p:pic>
      <p:pic>
        <p:nvPicPr>
          <p:cNvPr id="20" name="Picture 19" descr="Blue lights on a black background&#10;&#10;Description automatically generated with low confidence">
            <a:extLst>
              <a:ext uri="{FF2B5EF4-FFF2-40B4-BE49-F238E27FC236}">
                <a16:creationId xmlns:a16="http://schemas.microsoft.com/office/drawing/2014/main" id="{58761BA0-83E5-72CA-0160-5D3F61EB82A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22749" y="9576633"/>
            <a:ext cx="2343151" cy="2343151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DE26D4D4-EA2B-1F4A-8014-8ABDE387A37E}"/>
              </a:ext>
            </a:extLst>
          </p:cNvPr>
          <p:cNvSpPr txBox="1"/>
          <p:nvPr/>
        </p:nvSpPr>
        <p:spPr>
          <a:xfrm>
            <a:off x="271462" y="2501043"/>
            <a:ext cx="13715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R" sz="2000" b="1" dirty="0"/>
              <a:t>MeT-5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C2DB76B-9B99-4454-D9C5-68CF6DFCAA36}"/>
              </a:ext>
            </a:extLst>
          </p:cNvPr>
          <p:cNvSpPr txBox="1"/>
          <p:nvPr/>
        </p:nvSpPr>
        <p:spPr>
          <a:xfrm>
            <a:off x="271463" y="5183413"/>
            <a:ext cx="13715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R" sz="2000" b="1" dirty="0"/>
              <a:t>M14K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057FE93-973B-1ABE-FCC3-6262DC2F1CED}"/>
              </a:ext>
            </a:extLst>
          </p:cNvPr>
          <p:cNvSpPr txBox="1"/>
          <p:nvPr/>
        </p:nvSpPr>
        <p:spPr>
          <a:xfrm>
            <a:off x="292100" y="7937938"/>
            <a:ext cx="13715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R" sz="2000" b="1" dirty="0"/>
              <a:t>MSTO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295B027-A361-38C8-57F7-2AF9BC6F6406}"/>
              </a:ext>
            </a:extLst>
          </p:cNvPr>
          <p:cNvSpPr txBox="1"/>
          <p:nvPr/>
        </p:nvSpPr>
        <p:spPr>
          <a:xfrm>
            <a:off x="271462" y="10548153"/>
            <a:ext cx="13715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R" sz="2000" b="1" dirty="0"/>
              <a:t>pMPM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67F42FB-A9C1-7FB9-71F9-11DDAF200899}"/>
              </a:ext>
            </a:extLst>
          </p:cNvPr>
          <p:cNvSpPr txBox="1"/>
          <p:nvPr/>
        </p:nvSpPr>
        <p:spPr>
          <a:xfrm>
            <a:off x="2128838" y="759749"/>
            <a:ext cx="137159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R" sz="2000" b="1" dirty="0"/>
              <a:t>AlexaFluor 488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03AB8F0-3DFA-67DB-2A00-777EDB7297B3}"/>
              </a:ext>
            </a:extLst>
          </p:cNvPr>
          <p:cNvSpPr txBox="1"/>
          <p:nvPr/>
        </p:nvSpPr>
        <p:spPr>
          <a:xfrm>
            <a:off x="4708524" y="759748"/>
            <a:ext cx="13715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R" sz="2000" b="1" dirty="0"/>
              <a:t>Topro-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FC037C2-5678-3FB8-C70B-9D4940C1112E}"/>
              </a:ext>
            </a:extLst>
          </p:cNvPr>
          <p:cNvSpPr txBox="1"/>
          <p:nvPr/>
        </p:nvSpPr>
        <p:spPr>
          <a:xfrm>
            <a:off x="0" y="1726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R" sz="2400" b="1" dirty="0"/>
              <a:t>Confocal Images for PC (Raw Pictures Set 1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EBA7CB0-6836-B65F-593A-C78CF2ED88DF}"/>
              </a:ext>
            </a:extLst>
          </p:cNvPr>
          <p:cNvSpPr txBox="1"/>
          <p:nvPr/>
        </p:nvSpPr>
        <p:spPr>
          <a:xfrm>
            <a:off x="0" y="11869843"/>
            <a:ext cx="2594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R" b="1" dirty="0"/>
              <a:t>Supplementary Figure 1A</a:t>
            </a:r>
          </a:p>
        </p:txBody>
      </p:sp>
    </p:spTree>
    <p:extLst>
      <p:ext uri="{BB962C8B-B14F-4D97-AF65-F5344CB8AC3E}">
        <p14:creationId xmlns:p14="http://schemas.microsoft.com/office/powerpoint/2010/main" val="36334080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DE26D4D4-EA2B-1F4A-8014-8ABDE387A37E}"/>
              </a:ext>
            </a:extLst>
          </p:cNvPr>
          <p:cNvSpPr txBox="1"/>
          <p:nvPr/>
        </p:nvSpPr>
        <p:spPr>
          <a:xfrm>
            <a:off x="271462" y="2501043"/>
            <a:ext cx="13715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R" sz="2000" b="1" dirty="0"/>
              <a:t>MeT-5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C2DB76B-9B99-4454-D9C5-68CF6DFCAA36}"/>
              </a:ext>
            </a:extLst>
          </p:cNvPr>
          <p:cNvSpPr txBox="1"/>
          <p:nvPr/>
        </p:nvSpPr>
        <p:spPr>
          <a:xfrm>
            <a:off x="271463" y="5183413"/>
            <a:ext cx="13715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R" sz="2000" b="1" dirty="0"/>
              <a:t>M14K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057FE93-973B-1ABE-FCC3-6262DC2F1CED}"/>
              </a:ext>
            </a:extLst>
          </p:cNvPr>
          <p:cNvSpPr txBox="1"/>
          <p:nvPr/>
        </p:nvSpPr>
        <p:spPr>
          <a:xfrm>
            <a:off x="292100" y="7793439"/>
            <a:ext cx="13715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R" sz="2000" b="1" dirty="0"/>
              <a:t>MSTO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295B027-A361-38C8-57F7-2AF9BC6F6406}"/>
              </a:ext>
            </a:extLst>
          </p:cNvPr>
          <p:cNvSpPr txBox="1"/>
          <p:nvPr/>
        </p:nvSpPr>
        <p:spPr>
          <a:xfrm>
            <a:off x="271462" y="10548153"/>
            <a:ext cx="13715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R" sz="2000" b="1" dirty="0"/>
              <a:t>pMPM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67F42FB-A9C1-7FB9-71F9-11DDAF200899}"/>
              </a:ext>
            </a:extLst>
          </p:cNvPr>
          <p:cNvSpPr txBox="1"/>
          <p:nvPr/>
        </p:nvSpPr>
        <p:spPr>
          <a:xfrm>
            <a:off x="2128838" y="759749"/>
            <a:ext cx="137159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R" sz="2000" b="1" dirty="0"/>
              <a:t>AlexaFluor 488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03AB8F0-3DFA-67DB-2A00-777EDB7297B3}"/>
              </a:ext>
            </a:extLst>
          </p:cNvPr>
          <p:cNvSpPr txBox="1"/>
          <p:nvPr/>
        </p:nvSpPr>
        <p:spPr>
          <a:xfrm>
            <a:off x="4708524" y="759748"/>
            <a:ext cx="13715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R" sz="2000" b="1" dirty="0"/>
              <a:t>Topro-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FC037C2-5678-3FB8-C70B-9D4940C1112E}"/>
              </a:ext>
            </a:extLst>
          </p:cNvPr>
          <p:cNvSpPr txBox="1"/>
          <p:nvPr/>
        </p:nvSpPr>
        <p:spPr>
          <a:xfrm>
            <a:off x="0" y="1726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R" sz="2400" b="1" dirty="0"/>
              <a:t>Confocal Images for PC (Raw Pictures Set 2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EBA7CB0-6836-B65F-593A-C78CF2ED88DF}"/>
              </a:ext>
            </a:extLst>
          </p:cNvPr>
          <p:cNvSpPr txBox="1"/>
          <p:nvPr/>
        </p:nvSpPr>
        <p:spPr>
          <a:xfrm>
            <a:off x="0" y="11869843"/>
            <a:ext cx="25848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R" b="1" dirty="0"/>
              <a:t>Supplementary Figure 1B</a:t>
            </a:r>
          </a:p>
        </p:txBody>
      </p:sp>
      <p:pic>
        <p:nvPicPr>
          <p:cNvPr id="3" name="Picture 2" descr="Green spots on a black background&#10;&#10;Description automatically generated with low confidence">
            <a:extLst>
              <a:ext uri="{FF2B5EF4-FFF2-40B4-BE49-F238E27FC236}">
                <a16:creationId xmlns:a16="http://schemas.microsoft.com/office/drawing/2014/main" id="{48DAB1D9-D246-4C2D-F932-EEAD82E3E6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3062" y="1579508"/>
            <a:ext cx="2343152" cy="2343152"/>
          </a:xfrm>
          <a:prstGeom prst="rect">
            <a:avLst/>
          </a:prstGeom>
        </p:spPr>
      </p:pic>
      <p:pic>
        <p:nvPicPr>
          <p:cNvPr id="5" name="Picture 4" descr="Blue dots on a black background&#10;&#10;Description automatically generated with low confidence">
            <a:extLst>
              <a:ext uri="{FF2B5EF4-FFF2-40B4-BE49-F238E27FC236}">
                <a16:creationId xmlns:a16="http://schemas.microsoft.com/office/drawing/2014/main" id="{7DB03745-392B-D1A1-CED6-7B95405AB7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22747" y="1579508"/>
            <a:ext cx="2343152" cy="2343152"/>
          </a:xfrm>
          <a:prstGeom prst="rect">
            <a:avLst/>
          </a:prstGeom>
        </p:spPr>
      </p:pic>
      <p:pic>
        <p:nvPicPr>
          <p:cNvPr id="9" name="Picture 8" descr="A picture containing darkness, green&#10;&#10;Description automatically generated">
            <a:extLst>
              <a:ext uri="{FF2B5EF4-FFF2-40B4-BE49-F238E27FC236}">
                <a16:creationId xmlns:a16="http://schemas.microsoft.com/office/drawing/2014/main" id="{0CF12357-68C5-08EA-BA7F-5122278F8D9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63699" y="4200713"/>
            <a:ext cx="2343152" cy="2343152"/>
          </a:xfrm>
          <a:prstGeom prst="rect">
            <a:avLst/>
          </a:prstGeom>
        </p:spPr>
      </p:pic>
      <p:pic>
        <p:nvPicPr>
          <p:cNvPr id="13" name="Picture 12" descr="A picture containing majorelle blue, colorfulness, electric blue, blue&#10;&#10;Description automatically generated">
            <a:extLst>
              <a:ext uri="{FF2B5EF4-FFF2-40B4-BE49-F238E27FC236}">
                <a16:creationId xmlns:a16="http://schemas.microsoft.com/office/drawing/2014/main" id="{F1262586-9C3C-2270-696E-23B38C281FB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22747" y="4200713"/>
            <a:ext cx="2343151" cy="2343151"/>
          </a:xfrm>
          <a:prstGeom prst="rect">
            <a:avLst/>
          </a:prstGeom>
        </p:spPr>
      </p:pic>
      <p:pic>
        <p:nvPicPr>
          <p:cNvPr id="17" name="Picture 16" descr="A picture containing green, invertebrate&#10;&#10;Description automatically generated">
            <a:extLst>
              <a:ext uri="{FF2B5EF4-FFF2-40B4-BE49-F238E27FC236}">
                <a16:creationId xmlns:a16="http://schemas.microsoft.com/office/drawing/2014/main" id="{FA39B962-DB42-73C5-CE76-EEF1C63FAB0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63699" y="6821918"/>
            <a:ext cx="2343152" cy="2343152"/>
          </a:xfrm>
          <a:prstGeom prst="rect">
            <a:avLst/>
          </a:prstGeom>
        </p:spPr>
      </p:pic>
      <p:pic>
        <p:nvPicPr>
          <p:cNvPr id="29" name="Picture 28" descr="Blue spots on a black background&#10;&#10;Description automatically generated with low confidence">
            <a:extLst>
              <a:ext uri="{FF2B5EF4-FFF2-40B4-BE49-F238E27FC236}">
                <a16:creationId xmlns:a16="http://schemas.microsoft.com/office/drawing/2014/main" id="{C3F55D33-106C-1C00-ADDE-96C145B1102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22747" y="6821917"/>
            <a:ext cx="2343151" cy="2343151"/>
          </a:xfrm>
          <a:prstGeom prst="rect">
            <a:avLst/>
          </a:prstGeom>
        </p:spPr>
      </p:pic>
      <p:pic>
        <p:nvPicPr>
          <p:cNvPr id="31" name="Picture 30" descr="Green lights on a black background&#10;&#10;Description automatically generated with low confidence">
            <a:extLst>
              <a:ext uri="{FF2B5EF4-FFF2-40B4-BE49-F238E27FC236}">
                <a16:creationId xmlns:a16="http://schemas.microsoft.com/office/drawing/2014/main" id="{EB311913-CE05-D025-87F0-BE31472FFD0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663699" y="9443121"/>
            <a:ext cx="2343152" cy="2343152"/>
          </a:xfrm>
          <a:prstGeom prst="rect">
            <a:avLst/>
          </a:prstGeom>
        </p:spPr>
      </p:pic>
      <p:pic>
        <p:nvPicPr>
          <p:cNvPr id="33" name="Picture 32" descr="A picture containing invertebrate, aquarium, coelenterate, majorelle blue&#10;&#10;Description automatically generated">
            <a:extLst>
              <a:ext uri="{FF2B5EF4-FFF2-40B4-BE49-F238E27FC236}">
                <a16:creationId xmlns:a16="http://schemas.microsoft.com/office/drawing/2014/main" id="{2B6AE10E-4E5D-41B6-3A3F-6645058B64B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22747" y="9443121"/>
            <a:ext cx="2343151" cy="23431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81021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0</TotalTime>
  <Words>40</Words>
  <Application>Microsoft Macintosh PowerPoint</Application>
  <PresentationFormat>Widescreen</PresentationFormat>
  <Paragraphs>1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ROGIANNIS SOTIRIOS</dc:creator>
  <cp:lastModifiedBy>ZAROGIANNIS SOTIRIOS</cp:lastModifiedBy>
  <cp:revision>6</cp:revision>
  <dcterms:created xsi:type="dcterms:W3CDTF">2023-06-28T16:35:45Z</dcterms:created>
  <dcterms:modified xsi:type="dcterms:W3CDTF">2023-06-28T16:56:14Z</dcterms:modified>
</cp:coreProperties>
</file>